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12192000"/>
  <p:notesSz cx="6858000" cy="12192000"/>
  <p:defaultTextStyle>
    <a:defPPr>
      <a:defRPr lang="en-US"/>
    </a:defPPr>
    <a:lvl1pPr marL="0" algn="l" defTabSz="457200">
      <a:defRPr sz="18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>
      <a:defRPr sz="18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>
      <a:defRPr sz="18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>
      <a:defRPr sz="18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>
      <a:defRPr sz="18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>
      <a:defRPr sz="18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>
      <a:defRPr sz="18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>
      <a:defRPr sz="18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>
      <a:defRPr sz="18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3174" y="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" preserve="1" userDrawn="1">
  <p:cSld name="Title Slid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 bwMode="auto"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pPr>
              <a:defRPr/>
            </a:pPr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auto"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>
              <a:defRPr/>
            </a:pPr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x" preserve="1" userDrawn="1">
  <p:cSld name="Title and Vertical Tex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 bwMode="auto"/>
        <p:txBody>
          <a:bodyPr vert="eaVert"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itleAndTx" preserve="1" userDrawn="1">
  <p:cSld name="Vertical Title and Tex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 bwMode="auto">
          <a:xfrm>
            <a:off x="4907757" y="649111"/>
            <a:ext cx="1478756" cy="10332155"/>
          </a:xfrm>
        </p:spPr>
        <p:txBody>
          <a:bodyPr vert="eaVert"/>
          <a:lstStyle/>
          <a:p>
            <a:pPr>
              <a:defRPr/>
            </a:pPr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 bwMode="auto">
          <a:xfrm>
            <a:off x="471488" y="649111"/>
            <a:ext cx="4350544" cy="10332155"/>
          </a:xfrm>
        </p:spPr>
        <p:txBody>
          <a:bodyPr vert="eaVert"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" preserve="1" userDrawn="1">
  <p:cSld name="Title and Conten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/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secHead" preserve="1" userDrawn="1">
  <p:cSld name="Section Header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pPr>
              <a:defRPr/>
            </a:pPr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Obj" preserve="1" userDrawn="1">
  <p:cSld name="Two Conten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 bwMode="auto">
          <a:xfrm>
            <a:off x="471488" y="3245555"/>
            <a:ext cx="2914650" cy="7735712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 bwMode="auto">
          <a:xfrm>
            <a:off x="3471863" y="3245555"/>
            <a:ext cx="2914650" cy="7735712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TxTwoObj" preserve="1" userDrawn="1">
  <p:cSld name="Comparis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472381" y="649114"/>
            <a:ext cx="5915025" cy="2356556"/>
          </a:xfrm>
        </p:spPr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 bwMode="auto">
          <a:xfrm>
            <a:off x="472381" y="4453467"/>
            <a:ext cx="2901255" cy="6550379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 bwMode="auto"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 bwMode="auto">
          <a:xfrm>
            <a:off x="3471863" y="4453467"/>
            <a:ext cx="2915543" cy="6550379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Only" preserve="1" userDrawn="1">
  <p:cSld name="Title Only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blank" preserve="1" userDrawn="1">
  <p:cSld name="Blank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Tx" preserve="1" userDrawn="1">
  <p:cSld name="Content with Capti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pPr>
              <a:defRPr/>
            </a:pPr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auto"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picTx" preserve="1" userDrawn="1">
  <p:cSld name="Picture with Capti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pPr>
              <a:defRPr/>
            </a:pPr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 bwMode="auto"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>
              <a:defRPr/>
            </a:pPr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auto"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defRPr/>
            </a:pPr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3245555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7A7D2F5F-C53A-4084-B80C-DD27D4CC33F2}" type="datetimeFigureOut">
              <a:rPr lang="en-US"/>
              <a:t>12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74643BD-95E4-43B8-A12B-2987E16B11F8}" type="slidenum">
              <a:rPr lang="en-US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>
        <a:lnSpc>
          <a:spcPct val="90000"/>
        </a:lnSpc>
        <a:spcBef>
          <a:spcPts val="0"/>
        </a:spcBef>
        <a:buNone/>
        <a:defRPr sz="33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>
        <a:lnSpc>
          <a:spcPct val="90000"/>
        </a:lnSpc>
        <a:spcBef>
          <a:spcPts val="750"/>
        </a:spcBef>
        <a:buFont typeface="Arial"/>
        <a:buChar char="•"/>
        <a:defRPr sz="21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>
        <a:lnSpc>
          <a:spcPct val="90000"/>
        </a:lnSpc>
        <a:spcBef>
          <a:spcPts val="375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>
        <a:lnSpc>
          <a:spcPct val="90000"/>
        </a:lnSpc>
        <a:spcBef>
          <a:spcPts val="375"/>
        </a:spcBef>
        <a:buFont typeface="Arial"/>
        <a:buChar char="•"/>
        <a:defRPr sz="15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>
        <a:lnSpc>
          <a:spcPct val="90000"/>
        </a:lnSpc>
        <a:spcBef>
          <a:spcPts val="375"/>
        </a:spcBef>
        <a:buFont typeface="Arial"/>
        <a:buChar char="•"/>
        <a:defRPr sz="135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>
        <a:lnSpc>
          <a:spcPct val="90000"/>
        </a:lnSpc>
        <a:spcBef>
          <a:spcPts val="375"/>
        </a:spcBef>
        <a:buFont typeface="Arial"/>
        <a:buChar char="•"/>
        <a:defRPr sz="135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>
        <a:lnSpc>
          <a:spcPct val="90000"/>
        </a:lnSpc>
        <a:spcBef>
          <a:spcPts val="375"/>
        </a:spcBef>
        <a:buFont typeface="Arial"/>
        <a:buChar char="•"/>
        <a:defRPr sz="135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>
        <a:lnSpc>
          <a:spcPct val="90000"/>
        </a:lnSpc>
        <a:spcBef>
          <a:spcPts val="375"/>
        </a:spcBef>
        <a:buFont typeface="Arial"/>
        <a:buChar char="•"/>
        <a:defRPr sz="135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>
        <a:lnSpc>
          <a:spcPct val="90000"/>
        </a:lnSpc>
        <a:spcBef>
          <a:spcPts val="375"/>
        </a:spcBef>
        <a:buFont typeface="Arial"/>
        <a:buChar char="•"/>
        <a:defRPr sz="135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>
        <a:lnSpc>
          <a:spcPct val="90000"/>
        </a:lnSpc>
        <a:spcBef>
          <a:spcPts val="375"/>
        </a:spcBef>
        <a:buFont typeface="Arial"/>
        <a:buChar char="•"/>
        <a:defRPr sz="135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>
        <a:defRPr sz="135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>
        <a:defRPr sz="135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>
        <a:defRPr sz="135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>
        <a:defRPr sz="135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>
        <a:defRPr sz="135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>
        <a:defRPr sz="135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>
        <a:defRPr sz="135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>
        <a:defRPr sz="135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>
        <a:defRPr sz="135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 bwMode="auto">
          <a:xfrm>
            <a:off x="-24377" y="18625"/>
            <a:ext cx="6841669" cy="836799"/>
          </a:xfrm>
        </p:spPr>
        <p:txBody>
          <a:bodyPr>
            <a:normAutofit/>
          </a:bodyPr>
          <a:lstStyle/>
          <a:p>
            <a:pPr algn="just">
              <a:defRPr/>
            </a:pPr>
            <a:r>
              <a:rPr lang="de-DE" b="1" dirty="0"/>
              <a:t>Flow cytometric gating strategies</a:t>
            </a:r>
            <a:endParaRPr lang="en-US" b="1" dirty="0"/>
          </a:p>
        </p:txBody>
      </p:sp>
      <p:grpSp>
        <p:nvGrpSpPr>
          <p:cNvPr id="26" name="Group 25"/>
          <p:cNvGrpSpPr/>
          <p:nvPr/>
        </p:nvGrpSpPr>
        <p:grpSpPr bwMode="auto">
          <a:xfrm>
            <a:off x="-52167" y="813704"/>
            <a:ext cx="6899627" cy="3243846"/>
            <a:chOff x="-52167" y="1469571"/>
            <a:chExt cx="6899627" cy="3243846"/>
          </a:xfrm>
        </p:grpSpPr>
        <p:grpSp>
          <p:nvGrpSpPr>
            <p:cNvPr id="3" name="Group 2"/>
            <p:cNvGrpSpPr/>
            <p:nvPr/>
          </p:nvGrpSpPr>
          <p:grpSpPr bwMode="auto">
            <a:xfrm>
              <a:off x="-52167" y="1785431"/>
              <a:ext cx="6899627" cy="2927986"/>
              <a:chOff x="-68496" y="8300537"/>
              <a:chExt cx="6899627" cy="2927986"/>
            </a:xfrm>
          </p:grpSpPr>
          <p:grpSp>
            <p:nvGrpSpPr>
              <p:cNvPr id="99" name="Gruppieren 98"/>
              <p:cNvGrpSpPr/>
              <p:nvPr/>
            </p:nvGrpSpPr>
            <p:grpSpPr bwMode="auto">
              <a:xfrm>
                <a:off x="-68496" y="8631714"/>
                <a:ext cx="6899627" cy="2596809"/>
                <a:chOff x="-68496" y="8241189"/>
                <a:chExt cx="6899627" cy="2596809"/>
              </a:xfrm>
            </p:grpSpPr>
            <p:pic>
              <p:nvPicPr>
                <p:cNvPr id="71" name="Grafik 70"/>
                <p:cNvPicPr>
                  <a:picLocks noChangeAspect="1"/>
                </p:cNvPicPr>
                <p:nvPr/>
              </p:nvPicPr>
              <p:blipFill>
                <a:blip r:embed="rId2">
                  <a:grayscl/>
                </a:blip>
                <a:srcRect l="6290" b="6745"/>
                <a:stretch/>
              </p:blipFill>
              <p:spPr bwMode="auto">
                <a:xfrm>
                  <a:off x="190173" y="8673449"/>
                  <a:ext cx="1983141" cy="1929658"/>
                </a:xfrm>
                <a:prstGeom prst="rect">
                  <a:avLst/>
                </a:prstGeom>
              </p:spPr>
            </p:pic>
            <p:pic>
              <p:nvPicPr>
                <p:cNvPr id="73" name="Grafik 72"/>
                <p:cNvPicPr>
                  <a:picLocks noChangeAspect="1"/>
                </p:cNvPicPr>
                <p:nvPr/>
              </p:nvPicPr>
              <p:blipFill>
                <a:blip r:embed="rId3">
                  <a:grayscl/>
                </a:blip>
                <a:srcRect l="6942" b="6942"/>
                <a:stretch/>
              </p:blipFill>
              <p:spPr bwMode="auto">
                <a:xfrm>
                  <a:off x="2485968" y="8675154"/>
                  <a:ext cx="1969330" cy="1925588"/>
                </a:xfrm>
                <a:prstGeom prst="rect">
                  <a:avLst/>
                </a:prstGeom>
              </p:spPr>
            </p:pic>
            <p:pic>
              <p:nvPicPr>
                <p:cNvPr id="74" name="Grafik 73"/>
                <p:cNvPicPr>
                  <a:picLocks noChangeAspect="1"/>
                </p:cNvPicPr>
                <p:nvPr/>
              </p:nvPicPr>
              <p:blipFill>
                <a:blip r:embed="rId4"/>
                <a:srcRect l="8783" b="6942"/>
                <a:stretch/>
              </p:blipFill>
              <p:spPr bwMode="auto">
                <a:xfrm>
                  <a:off x="4809022" y="8688045"/>
                  <a:ext cx="1930381" cy="1925588"/>
                </a:xfrm>
                <a:prstGeom prst="rect">
                  <a:avLst/>
                </a:prstGeom>
              </p:spPr>
            </p:pic>
            <p:cxnSp>
              <p:nvCxnSpPr>
                <p:cNvPr id="75" name="Gerade Verbindung mit Pfeil 74"/>
                <p:cNvCxnSpPr>
                  <a:cxnSpLocks/>
                </p:cNvCxnSpPr>
                <p:nvPr/>
              </p:nvCxnSpPr>
              <p:spPr bwMode="auto">
                <a:xfrm flipV="1">
                  <a:off x="171290" y="8647957"/>
                  <a:ext cx="0" cy="1948286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6" name="Textfeld 129"/>
                <p:cNvSpPr txBox="1"/>
                <p:nvPr/>
              </p:nvSpPr>
              <p:spPr bwMode="auto">
                <a:xfrm rot="16199998">
                  <a:off x="-205318" y="9416784"/>
                  <a:ext cx="513429" cy="2397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  <a:defRPr/>
                  </a:pPr>
                  <a:r>
                    <a:rPr lang="de-DE" sz="1200" b="1">
                      <a:solidFill>
                        <a:srgbClr val="000000"/>
                      </a:solidFill>
                      <a:latin typeface="Calibri"/>
                      <a:ea typeface="Times New Roman"/>
                      <a:cs typeface="Times New Roman"/>
                    </a:rPr>
                    <a:t>SSC</a:t>
                  </a:r>
                  <a:endParaRPr lang="en-US" sz="1100">
                    <a:latin typeface="Calibri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77" name="Textfeld 133"/>
                <p:cNvSpPr txBox="1"/>
                <p:nvPr/>
              </p:nvSpPr>
              <p:spPr bwMode="auto">
                <a:xfrm>
                  <a:off x="902110" y="10596243"/>
                  <a:ext cx="533116" cy="2417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  <a:defRPr/>
                  </a:pPr>
                  <a:r>
                    <a:rPr lang="de-DE" sz="1100" b="1">
                      <a:solidFill>
                        <a:srgbClr val="000000"/>
                      </a:solidFill>
                      <a:latin typeface="Calibri"/>
                      <a:ea typeface="Times New Roman"/>
                      <a:cs typeface="Times New Roman"/>
                    </a:rPr>
                    <a:t>FSC</a:t>
                  </a:r>
                  <a:endParaRPr lang="en-US" sz="1100">
                    <a:latin typeface="Calibri"/>
                    <a:ea typeface="Calibri"/>
                    <a:cs typeface="Times New Roman"/>
                  </a:endParaRPr>
                </a:p>
              </p:txBody>
            </p:sp>
            <p:cxnSp>
              <p:nvCxnSpPr>
                <p:cNvPr id="78" name="Gerade Verbindung mit Pfeil 77"/>
                <p:cNvCxnSpPr>
                  <a:cxnSpLocks/>
                </p:cNvCxnSpPr>
                <p:nvPr/>
              </p:nvCxnSpPr>
              <p:spPr bwMode="auto">
                <a:xfrm>
                  <a:off x="171290" y="10596243"/>
                  <a:ext cx="2060573" cy="0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Gerade Verbindung mit Pfeil 78"/>
                <p:cNvCxnSpPr>
                  <a:cxnSpLocks/>
                </p:cNvCxnSpPr>
                <p:nvPr/>
              </p:nvCxnSpPr>
              <p:spPr bwMode="auto">
                <a:xfrm flipV="1">
                  <a:off x="2462716" y="8647957"/>
                  <a:ext cx="0" cy="1948286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0" name="Textfeld 129"/>
                <p:cNvSpPr txBox="1"/>
                <p:nvPr/>
              </p:nvSpPr>
              <p:spPr bwMode="auto">
                <a:xfrm rot="16199998">
                  <a:off x="2069317" y="9399994"/>
                  <a:ext cx="547010" cy="2397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  <a:defRPr/>
                  </a:pPr>
                  <a:r>
                    <a:rPr lang="de-DE" sz="1200" b="1">
                      <a:solidFill>
                        <a:srgbClr val="000000"/>
                      </a:solidFill>
                      <a:latin typeface="Calibri"/>
                      <a:ea typeface="Times New Roman"/>
                      <a:cs typeface="Times New Roman"/>
                    </a:rPr>
                    <a:t>FSC-H</a:t>
                  </a:r>
                  <a:endParaRPr lang="en-US" sz="1100">
                    <a:latin typeface="Calibri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81" name="Textfeld 133"/>
                <p:cNvSpPr txBox="1"/>
                <p:nvPr/>
              </p:nvSpPr>
              <p:spPr bwMode="auto">
                <a:xfrm>
                  <a:off x="3193536" y="10596243"/>
                  <a:ext cx="533116" cy="2417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  <a:defRPr/>
                  </a:pPr>
                  <a:r>
                    <a:rPr lang="de-DE" sz="1100" b="1">
                      <a:solidFill>
                        <a:srgbClr val="000000"/>
                      </a:solidFill>
                      <a:latin typeface="Calibri"/>
                      <a:ea typeface="Times New Roman"/>
                      <a:cs typeface="Times New Roman"/>
                    </a:rPr>
                    <a:t>FSC-A</a:t>
                  </a:r>
                  <a:endParaRPr lang="en-US" sz="1100">
                    <a:latin typeface="Calibri"/>
                    <a:ea typeface="Calibri"/>
                    <a:cs typeface="Times New Roman"/>
                  </a:endParaRPr>
                </a:p>
              </p:txBody>
            </p:sp>
            <p:cxnSp>
              <p:nvCxnSpPr>
                <p:cNvPr id="82" name="Gerade Verbindung mit Pfeil 81"/>
                <p:cNvCxnSpPr>
                  <a:cxnSpLocks/>
                </p:cNvCxnSpPr>
                <p:nvPr/>
              </p:nvCxnSpPr>
              <p:spPr bwMode="auto">
                <a:xfrm>
                  <a:off x="2462716" y="10596243"/>
                  <a:ext cx="2060574" cy="0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Gerade Verbindung mit Pfeil 82"/>
                <p:cNvCxnSpPr>
                  <a:cxnSpLocks/>
                </p:cNvCxnSpPr>
                <p:nvPr/>
              </p:nvCxnSpPr>
              <p:spPr bwMode="auto">
                <a:xfrm flipV="1">
                  <a:off x="4770557" y="8647957"/>
                  <a:ext cx="0" cy="1948286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4" name="Textfeld 129"/>
                <p:cNvSpPr txBox="1"/>
                <p:nvPr/>
              </p:nvSpPr>
              <p:spPr bwMode="auto">
                <a:xfrm rot="16199998">
                  <a:off x="4348585" y="9371420"/>
                  <a:ext cx="604158" cy="2397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  <a:defRPr/>
                  </a:pPr>
                  <a:r>
                    <a:rPr lang="de-DE" sz="1200" b="1">
                      <a:solidFill>
                        <a:srgbClr val="000000"/>
                      </a:solidFill>
                      <a:latin typeface="Calibri"/>
                      <a:ea typeface="Times New Roman"/>
                      <a:cs typeface="Times New Roman"/>
                    </a:rPr>
                    <a:t>Count</a:t>
                  </a:r>
                  <a:endParaRPr lang="en-US" sz="1100">
                    <a:latin typeface="Calibri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85" name="Textfeld 133"/>
                <p:cNvSpPr txBox="1"/>
                <p:nvPr/>
              </p:nvSpPr>
              <p:spPr bwMode="auto">
                <a:xfrm>
                  <a:off x="5306177" y="10575587"/>
                  <a:ext cx="916157" cy="2417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  <a:defRPr/>
                  </a:pPr>
                  <a:r>
                    <a:rPr lang="de-DE" sz="1100" b="1">
                      <a:solidFill>
                        <a:srgbClr val="000000"/>
                      </a:solidFill>
                      <a:latin typeface="Calibri"/>
                      <a:ea typeface="Times New Roman"/>
                      <a:cs typeface="Times New Roman"/>
                    </a:rPr>
                    <a:t>CD41a</a:t>
                  </a:r>
                  <a:endParaRPr lang="en-US" sz="1100">
                    <a:latin typeface="Calibri"/>
                    <a:ea typeface="Calibri"/>
                    <a:cs typeface="Times New Roman"/>
                  </a:endParaRPr>
                </a:p>
              </p:txBody>
            </p:sp>
            <p:cxnSp>
              <p:nvCxnSpPr>
                <p:cNvPr id="86" name="Gerade Verbindung mit Pfeil 85"/>
                <p:cNvCxnSpPr>
                  <a:cxnSpLocks/>
                </p:cNvCxnSpPr>
                <p:nvPr/>
              </p:nvCxnSpPr>
              <p:spPr bwMode="auto">
                <a:xfrm>
                  <a:off x="4770557" y="10596243"/>
                  <a:ext cx="2060574" cy="0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Gerader Verbinder 87"/>
                <p:cNvCxnSpPr>
                  <a:cxnSpLocks/>
                </p:cNvCxnSpPr>
                <p:nvPr/>
              </p:nvCxnSpPr>
              <p:spPr bwMode="auto">
                <a:xfrm>
                  <a:off x="5735993" y="8721899"/>
                  <a:ext cx="0" cy="173578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Gerader Verbinder 88"/>
                <p:cNvCxnSpPr>
                  <a:cxnSpLocks/>
                </p:cNvCxnSpPr>
                <p:nvPr/>
              </p:nvCxnSpPr>
              <p:spPr bwMode="auto">
                <a:xfrm>
                  <a:off x="6136995" y="8721899"/>
                  <a:ext cx="0" cy="173578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Gerader Verbinder 89"/>
                <p:cNvCxnSpPr>
                  <a:cxnSpLocks/>
                </p:cNvCxnSpPr>
                <p:nvPr/>
              </p:nvCxnSpPr>
              <p:spPr bwMode="auto">
                <a:xfrm>
                  <a:off x="5740756" y="9519887"/>
                  <a:ext cx="39334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1" name="Textfeld 90"/>
                <p:cNvSpPr txBox="1"/>
                <p:nvPr/>
              </p:nvSpPr>
              <p:spPr bwMode="auto">
                <a:xfrm>
                  <a:off x="851921" y="8241190"/>
                  <a:ext cx="6864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defRPr/>
                  </a:pPr>
                  <a:r>
                    <a:rPr lang="de-DE" sz="1200" b="1"/>
                    <a:t>All cells</a:t>
                  </a:r>
                </a:p>
              </p:txBody>
            </p:sp>
            <p:sp>
              <p:nvSpPr>
                <p:cNvPr id="92" name="Textfeld 91"/>
                <p:cNvSpPr txBox="1"/>
                <p:nvPr/>
              </p:nvSpPr>
              <p:spPr bwMode="auto">
                <a:xfrm>
                  <a:off x="3114183" y="8241190"/>
                  <a:ext cx="68640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defRPr/>
                  </a:pPr>
                  <a:r>
                    <a:rPr lang="de-DE" sz="1200" b="1"/>
                    <a:t>Singlets</a:t>
                  </a:r>
                </a:p>
              </p:txBody>
            </p:sp>
            <p:sp>
              <p:nvSpPr>
                <p:cNvPr id="93" name="Textfeld 92"/>
                <p:cNvSpPr txBox="1"/>
                <p:nvPr/>
              </p:nvSpPr>
              <p:spPr bwMode="auto">
                <a:xfrm>
                  <a:off x="5457641" y="8241189"/>
                  <a:ext cx="80199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defRPr/>
                  </a:pPr>
                  <a:r>
                    <a:rPr lang="de-DE" sz="1200" b="1"/>
                    <a:t>CD41a</a:t>
                  </a:r>
                  <a:r>
                    <a:rPr lang="de-DE" sz="1200" b="1" baseline="30000"/>
                    <a:t>+</a:t>
                  </a:r>
                  <a:endParaRPr/>
                </a:p>
              </p:txBody>
            </p:sp>
            <p:cxnSp>
              <p:nvCxnSpPr>
                <p:cNvPr id="94" name="Gerade Verbindung mit Pfeil 93"/>
                <p:cNvCxnSpPr>
                  <a:cxnSpLocks/>
                  <a:stCxn id="91" idx="3"/>
                  <a:endCxn id="92" idx="1"/>
                </p:cNvCxnSpPr>
                <p:nvPr/>
              </p:nvCxnSpPr>
              <p:spPr bwMode="auto">
                <a:xfrm>
                  <a:off x="1538327" y="8379690"/>
                  <a:ext cx="1575856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Gerade Verbindung mit Pfeil 94"/>
                <p:cNvCxnSpPr>
                  <a:cxnSpLocks/>
                  <a:stCxn id="92" idx="3"/>
                  <a:endCxn id="93" idx="1"/>
                </p:cNvCxnSpPr>
                <p:nvPr/>
              </p:nvCxnSpPr>
              <p:spPr bwMode="auto">
                <a:xfrm flipV="1">
                  <a:off x="3800589" y="8379688"/>
                  <a:ext cx="1657052" cy="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7" name="Freihandform: Form 96"/>
                <p:cNvSpPr/>
                <p:nvPr/>
              </p:nvSpPr>
              <p:spPr bwMode="auto">
                <a:xfrm>
                  <a:off x="1504950" y="8920163"/>
                  <a:ext cx="557213" cy="1000125"/>
                </a:xfrm>
                <a:custGeom>
                  <a:avLst/>
                  <a:gdLst>
                    <a:gd name="connsiteX0" fmla="*/ 85725 w 557213"/>
                    <a:gd name="connsiteY0" fmla="*/ 0 h 1000125"/>
                    <a:gd name="connsiteX1" fmla="*/ 0 w 557213"/>
                    <a:gd name="connsiteY1" fmla="*/ 733425 h 1000125"/>
                    <a:gd name="connsiteX2" fmla="*/ 152400 w 557213"/>
                    <a:gd name="connsiteY2" fmla="*/ 1000125 h 1000125"/>
                    <a:gd name="connsiteX3" fmla="*/ 495300 w 557213"/>
                    <a:gd name="connsiteY3" fmla="*/ 552450 h 1000125"/>
                    <a:gd name="connsiteX4" fmla="*/ 557213 w 557213"/>
                    <a:gd name="connsiteY4" fmla="*/ 214312 h 1000125"/>
                    <a:gd name="connsiteX5" fmla="*/ 323850 w 557213"/>
                    <a:gd name="connsiteY5" fmla="*/ 14287 h 1000125"/>
                    <a:gd name="connsiteX6" fmla="*/ 85725 w 557213"/>
                    <a:gd name="connsiteY6" fmla="*/ 0 h 10001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557213" h="1000125" extrusionOk="0">
                      <a:moveTo>
                        <a:pt x="85725" y="0"/>
                      </a:moveTo>
                      <a:lnTo>
                        <a:pt x="0" y="733425"/>
                      </a:lnTo>
                      <a:lnTo>
                        <a:pt x="152400" y="1000125"/>
                      </a:lnTo>
                      <a:lnTo>
                        <a:pt x="495300" y="552450"/>
                      </a:lnTo>
                      <a:lnTo>
                        <a:pt x="557213" y="214312"/>
                      </a:lnTo>
                      <a:lnTo>
                        <a:pt x="323850" y="14287"/>
                      </a:lnTo>
                      <a:lnTo>
                        <a:pt x="85725" y="0"/>
                      </a:lnTo>
                      <a:close/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defRPr/>
                  </a:pPr>
                  <a:endParaRPr lang="de-DE"/>
                </a:p>
              </p:txBody>
            </p:sp>
            <p:sp>
              <p:nvSpPr>
                <p:cNvPr id="98" name="Rechteck 97"/>
                <p:cNvSpPr/>
                <p:nvPr/>
              </p:nvSpPr>
              <p:spPr bwMode="auto">
                <a:xfrm rot="13643540">
                  <a:off x="3796013" y="8778435"/>
                  <a:ext cx="116087" cy="114199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>
                    <a:defRPr/>
                  </a:pPr>
                  <a:endParaRPr lang="de-DE"/>
                </a:p>
              </p:txBody>
            </p:sp>
          </p:grpSp>
          <p:sp>
            <p:nvSpPr>
              <p:cNvPr id="100" name="Textfeld 99"/>
              <p:cNvSpPr txBox="1"/>
              <p:nvPr/>
            </p:nvSpPr>
            <p:spPr bwMode="auto">
              <a:xfrm>
                <a:off x="-60013" y="8300537"/>
                <a:ext cx="110049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de-DE" sz="1200" b="1"/>
                  <a:t>iPRF-Platelets:</a:t>
                </a:r>
                <a:endParaRPr/>
              </a:p>
            </p:txBody>
          </p:sp>
        </p:grpSp>
        <p:sp>
          <p:nvSpPr>
            <p:cNvPr id="11" name="TextBox 10"/>
            <p:cNvSpPr txBox="1"/>
            <p:nvPr/>
          </p:nvSpPr>
          <p:spPr bwMode="auto">
            <a:xfrm>
              <a:off x="-48990" y="1469571"/>
              <a:ext cx="5577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b="1"/>
                <a:t>A</a:t>
              </a:r>
              <a:endParaRPr/>
            </a:p>
          </p:txBody>
        </p:sp>
      </p:grpSp>
      <p:grpSp>
        <p:nvGrpSpPr>
          <p:cNvPr id="29" name="Group 28"/>
          <p:cNvGrpSpPr/>
          <p:nvPr/>
        </p:nvGrpSpPr>
        <p:grpSpPr bwMode="auto">
          <a:xfrm>
            <a:off x="-57956" y="4070484"/>
            <a:ext cx="6899627" cy="3332322"/>
            <a:chOff x="-57956" y="4750461"/>
            <a:chExt cx="6899627" cy="3332322"/>
          </a:xfrm>
        </p:grpSpPr>
        <p:grpSp>
          <p:nvGrpSpPr>
            <p:cNvPr id="41" name="Gruppieren 40"/>
            <p:cNvGrpSpPr/>
            <p:nvPr/>
          </p:nvGrpSpPr>
          <p:grpSpPr bwMode="auto">
            <a:xfrm>
              <a:off x="-57956" y="5046808"/>
              <a:ext cx="6899627" cy="3035975"/>
              <a:chOff x="-41627" y="3726767"/>
              <a:chExt cx="6899627" cy="3035975"/>
            </a:xfrm>
          </p:grpSpPr>
          <p:grpSp>
            <p:nvGrpSpPr>
              <p:cNvPr id="39" name="Gruppieren 38"/>
              <p:cNvGrpSpPr/>
              <p:nvPr/>
            </p:nvGrpSpPr>
            <p:grpSpPr bwMode="auto">
              <a:xfrm>
                <a:off x="-41627" y="4032582"/>
                <a:ext cx="6899627" cy="2730160"/>
                <a:chOff x="-127352" y="4619322"/>
                <a:chExt cx="6899627" cy="2730160"/>
              </a:xfrm>
            </p:grpSpPr>
            <p:grpSp>
              <p:nvGrpSpPr>
                <p:cNvPr id="31" name="Gruppieren 30"/>
                <p:cNvGrpSpPr>
                  <a:grpSpLocks noChangeAspect="1"/>
                </p:cNvGrpSpPr>
                <p:nvPr/>
              </p:nvGrpSpPr>
              <p:grpSpPr bwMode="auto">
                <a:xfrm>
                  <a:off x="-127352" y="5159440"/>
                  <a:ext cx="6899627" cy="2190042"/>
                  <a:chOff x="-151164" y="4920149"/>
                  <a:chExt cx="7638500" cy="2424571"/>
                </a:xfrm>
              </p:grpSpPr>
              <p:grpSp>
                <p:nvGrpSpPr>
                  <p:cNvPr id="21" name="Gruppieren 20"/>
                  <p:cNvGrpSpPr/>
                  <p:nvPr/>
                </p:nvGrpSpPr>
                <p:grpSpPr bwMode="auto">
                  <a:xfrm>
                    <a:off x="-151164" y="4920149"/>
                    <a:ext cx="7638500" cy="2424571"/>
                    <a:chOff x="-151164" y="4920149"/>
                    <a:chExt cx="7638500" cy="2424571"/>
                  </a:xfrm>
                </p:grpSpPr>
                <p:pic>
                  <p:nvPicPr>
                    <p:cNvPr id="5" name="Grafik 4"/>
                    <p:cNvPicPr>
                      <a:picLocks noChangeAspect="1"/>
                    </p:cNvPicPr>
                    <p:nvPr/>
                  </p:nvPicPr>
                  <p:blipFill>
                    <a:blip r:embed="rId5"/>
                    <a:srcRect l="7734" b="8245"/>
                    <a:stretch/>
                  </p:blipFill>
                  <p:spPr bwMode="auto">
                    <a:xfrm>
                      <a:off x="2675975" y="4955381"/>
                      <a:ext cx="2152650" cy="209312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6" name="Grafik 5"/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rcRect l="9209" b="6994"/>
                    <a:stretch/>
                  </p:blipFill>
                  <p:spPr bwMode="auto">
                    <a:xfrm>
                      <a:off x="5214939" y="4950618"/>
                      <a:ext cx="2118227" cy="2121696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12" name="Gruppieren 11"/>
                    <p:cNvGrpSpPr/>
                    <p:nvPr/>
                  </p:nvGrpSpPr>
                  <p:grpSpPr bwMode="auto">
                    <a:xfrm>
                      <a:off x="-151164" y="4920149"/>
                      <a:ext cx="2546702" cy="2424570"/>
                      <a:chOff x="206023" y="4891575"/>
                      <a:chExt cx="2546702" cy="2424570"/>
                    </a:xfrm>
                  </p:grpSpPr>
                  <p:pic>
                    <p:nvPicPr>
                      <p:cNvPr id="4" name="Grafik 3"/>
                      <p:cNvPicPr>
                        <a:picLocks noChangeAspect="1"/>
                      </p:cNvPicPr>
                      <p:nvPr/>
                    </p:nvPicPr>
                    <p:blipFill>
                      <a:blip r:embed="rId7"/>
                      <a:srcRect l="5897" t="1" b="8245"/>
                      <a:stretch/>
                    </p:blipFill>
                    <p:spPr bwMode="auto">
                      <a:xfrm>
                        <a:off x="471487" y="4955381"/>
                        <a:ext cx="2195513" cy="2093120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7" name="Gerade Verbindung mit Pfeil 6"/>
                      <p:cNvCxnSpPr>
                        <a:cxnSpLocks/>
                      </p:cNvCxnSpPr>
                      <p:nvPr/>
                    </p:nvCxnSpPr>
                    <p:spPr bwMode="auto">
                      <a:xfrm flipV="1">
                        <a:off x="471487" y="4891575"/>
                        <a:ext cx="0" cy="2156926"/>
                      </a:xfrm>
                      <a:prstGeom prst="straightConnector1">
                        <a:avLst/>
                      </a:prstGeom>
                      <a:ln w="1905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8" name="Textfeld 129"/>
                      <p:cNvSpPr txBox="1"/>
                      <p:nvPr/>
                    </p:nvSpPr>
                    <p:spPr bwMode="auto">
                      <a:xfrm rot="16199998">
                        <a:off x="54549" y="5742735"/>
                        <a:ext cx="568411" cy="26546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  <a:defRPr/>
                        </a:pPr>
                        <a:r>
                          <a:rPr lang="de-DE" sz="1200" b="1">
                            <a:solidFill>
                              <a:srgbClr val="000000"/>
                            </a:solidFill>
                            <a:latin typeface="Calibri"/>
                            <a:ea typeface="Times New Roman"/>
                            <a:cs typeface="Times New Roman"/>
                          </a:rPr>
                          <a:t>SSC</a:t>
                        </a:r>
                        <a:endParaRPr lang="en-US" sz="1100">
                          <a:latin typeface="Calibri"/>
                          <a:ea typeface="Calibri"/>
                          <a:cs typeface="Times New Roman"/>
                        </a:endParaRPr>
                      </a:p>
                    </p:txBody>
                  </p:sp>
                  <p:sp>
                    <p:nvSpPr>
                      <p:cNvPr id="9" name="Textfeld 133"/>
                      <p:cNvSpPr txBox="1"/>
                      <p:nvPr/>
                    </p:nvSpPr>
                    <p:spPr bwMode="auto">
                      <a:xfrm>
                        <a:off x="1280570" y="7048500"/>
                        <a:ext cx="590207" cy="2676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noAutofit/>
                      </a:bodyPr>
                      <a:lstStyle/>
                      <a:p>
                        <a:pPr algn="ctr">
                          <a:lnSpc>
                            <a:spcPct val="107000"/>
                          </a:lnSpc>
                          <a:spcAft>
                            <a:spcPts val="800"/>
                          </a:spcAft>
                          <a:defRPr/>
                        </a:pPr>
                        <a:r>
                          <a:rPr lang="de-DE" sz="1100" b="1">
                            <a:solidFill>
                              <a:srgbClr val="000000"/>
                            </a:solidFill>
                            <a:latin typeface="Calibri"/>
                            <a:ea typeface="Times New Roman"/>
                            <a:cs typeface="Times New Roman"/>
                          </a:rPr>
                          <a:t>FSC</a:t>
                        </a:r>
                        <a:endParaRPr lang="en-US" sz="1100">
                          <a:latin typeface="Calibri"/>
                          <a:ea typeface="Calibri"/>
                          <a:cs typeface="Times New Roman"/>
                        </a:endParaRPr>
                      </a:p>
                    </p:txBody>
                  </p:sp>
                  <p:cxnSp>
                    <p:nvCxnSpPr>
                      <p:cNvPr id="10" name="Gerade Verbindung mit Pfeil 9"/>
                      <p:cNvCxnSpPr>
                        <a:cxnSpLocks/>
                      </p:cNvCxnSpPr>
                      <p:nvPr/>
                    </p:nvCxnSpPr>
                    <p:spPr bwMode="auto">
                      <a:xfrm>
                        <a:off x="471487" y="7048500"/>
                        <a:ext cx="2281238" cy="0"/>
                      </a:xfrm>
                      <a:prstGeom prst="straightConnector1">
                        <a:avLst/>
                      </a:prstGeom>
                      <a:ln w="19050">
                        <a:tailEnd type="triangle"/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13" name="Gerade Verbindung mit Pfeil 12"/>
                    <p:cNvCxnSpPr>
                      <a:cxnSpLocks/>
                    </p:cNvCxnSpPr>
                    <p:nvPr/>
                  </p:nvCxnSpPr>
                  <p:spPr bwMode="auto">
                    <a:xfrm flipV="1">
                      <a:off x="2651112" y="4920149"/>
                      <a:ext cx="0" cy="2156926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4" name="Textfeld 129"/>
                    <p:cNvSpPr txBox="1"/>
                    <p:nvPr/>
                  </p:nvSpPr>
                  <p:spPr bwMode="auto">
                    <a:xfrm rot="16199998">
                      <a:off x="2215585" y="5752722"/>
                      <a:ext cx="605589" cy="2654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defRPr/>
                      </a:pPr>
                      <a:r>
                        <a:rPr lang="de-DE" sz="1200" b="1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Times New Roman"/>
                        </a:rPr>
                        <a:t>FSC-H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p:txBody>
                </p:sp>
                <p:sp>
                  <p:nvSpPr>
                    <p:cNvPr id="15" name="Textfeld 133"/>
                    <p:cNvSpPr txBox="1"/>
                    <p:nvPr/>
                  </p:nvSpPr>
                  <p:spPr bwMode="auto">
                    <a:xfrm>
                      <a:off x="3460195" y="7077076"/>
                      <a:ext cx="590207" cy="2676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defRPr/>
                      </a:pPr>
                      <a:r>
                        <a:rPr lang="de-DE" sz="1100" b="1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Times New Roman"/>
                        </a:rPr>
                        <a:t>FSC-A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p:txBody>
                </p:sp>
                <p:cxnSp>
                  <p:nvCxnSpPr>
                    <p:cNvPr id="16" name="Gerade Verbindung mit Pfeil 15"/>
                    <p:cNvCxnSpPr>
                      <a:cxnSpLocks/>
                    </p:cNvCxnSpPr>
                    <p:nvPr/>
                  </p:nvCxnSpPr>
                  <p:spPr bwMode="auto">
                    <a:xfrm>
                      <a:off x="2651112" y="7077076"/>
                      <a:ext cx="2281238" cy="0"/>
                    </a:xfrm>
                    <a:prstGeom prst="straightConnector1">
                      <a:avLst/>
                    </a:prstGeom>
                    <a:ln w="1905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" name="Gerade Verbindung mit Pfeil 16"/>
                    <p:cNvCxnSpPr>
                      <a:cxnSpLocks/>
                    </p:cNvCxnSpPr>
                    <p:nvPr/>
                  </p:nvCxnSpPr>
                  <p:spPr bwMode="auto">
                    <a:xfrm flipV="1">
                      <a:off x="5206098" y="4920149"/>
                      <a:ext cx="0" cy="2156926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8" name="Textfeld 129"/>
                    <p:cNvSpPr txBox="1"/>
                    <p:nvPr/>
                  </p:nvSpPr>
                  <p:spPr bwMode="auto">
                    <a:xfrm rot="16199998">
                      <a:off x="4738937" y="5721088"/>
                      <a:ext cx="668857" cy="2654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defRPr/>
                      </a:pPr>
                      <a:r>
                        <a:rPr lang="de-DE" sz="1200" b="1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Times New Roman"/>
                        </a:rPr>
                        <a:t>Count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p:txBody>
                </p:sp>
                <p:sp>
                  <p:nvSpPr>
                    <p:cNvPr id="19" name="Textfeld 133"/>
                    <p:cNvSpPr txBox="1"/>
                    <p:nvPr/>
                  </p:nvSpPr>
                  <p:spPr bwMode="auto">
                    <a:xfrm>
                      <a:off x="5799076" y="7054207"/>
                      <a:ext cx="1147608" cy="2869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defRPr/>
                      </a:pPr>
                      <a:r>
                        <a:rPr lang="de-DE" sz="1100" b="1" i="0" u="none" strike="noStrike" cap="none" spc="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Times New Roman"/>
                        </a:rPr>
                        <a:t>Viability</a:t>
                      </a:r>
                      <a:r>
                        <a:rPr lang="de-DE" sz="1100" b="1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Times New Roman"/>
                        </a:rPr>
                        <a:t> Dye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</p:txBody>
                </p:sp>
                <p:cxnSp>
                  <p:nvCxnSpPr>
                    <p:cNvPr id="20" name="Gerade Verbindung mit Pfeil 19"/>
                    <p:cNvCxnSpPr>
                      <a:cxnSpLocks/>
                    </p:cNvCxnSpPr>
                    <p:nvPr/>
                  </p:nvCxnSpPr>
                  <p:spPr bwMode="auto">
                    <a:xfrm>
                      <a:off x="5206098" y="7077076"/>
                      <a:ext cx="2281238" cy="0"/>
                    </a:xfrm>
                    <a:prstGeom prst="straightConnector1">
                      <a:avLst/>
                    </a:prstGeom>
                    <a:ln w="1905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3" name="Freihandform: Form 22"/>
                  <p:cNvSpPr/>
                  <p:nvPr/>
                </p:nvSpPr>
                <p:spPr bwMode="auto">
                  <a:xfrm>
                    <a:off x="571500" y="5762625"/>
                    <a:ext cx="1352550" cy="1062038"/>
                  </a:xfrm>
                  <a:custGeom>
                    <a:avLst/>
                    <a:gdLst>
                      <a:gd name="connsiteX0" fmla="*/ 19050 w 1352550"/>
                      <a:gd name="connsiteY0" fmla="*/ 952500 h 1062038"/>
                      <a:gd name="connsiteX1" fmla="*/ 0 w 1352550"/>
                      <a:gd name="connsiteY1" fmla="*/ 595313 h 1062038"/>
                      <a:gd name="connsiteX2" fmla="*/ 295275 w 1352550"/>
                      <a:gd name="connsiteY2" fmla="*/ 180975 h 1062038"/>
                      <a:gd name="connsiteX3" fmla="*/ 666750 w 1352550"/>
                      <a:gd name="connsiteY3" fmla="*/ 52388 h 1062038"/>
                      <a:gd name="connsiteX4" fmla="*/ 1062038 w 1352550"/>
                      <a:gd name="connsiteY4" fmla="*/ 0 h 1062038"/>
                      <a:gd name="connsiteX5" fmla="*/ 1304925 w 1352550"/>
                      <a:gd name="connsiteY5" fmla="*/ 180975 h 1062038"/>
                      <a:gd name="connsiteX6" fmla="*/ 1352550 w 1352550"/>
                      <a:gd name="connsiteY6" fmla="*/ 542925 h 1062038"/>
                      <a:gd name="connsiteX7" fmla="*/ 1300163 w 1352550"/>
                      <a:gd name="connsiteY7" fmla="*/ 823913 h 1062038"/>
                      <a:gd name="connsiteX8" fmla="*/ 766763 w 1352550"/>
                      <a:gd name="connsiteY8" fmla="*/ 1028700 h 1062038"/>
                      <a:gd name="connsiteX9" fmla="*/ 266700 w 1352550"/>
                      <a:gd name="connsiteY9" fmla="*/ 1062038 h 1062038"/>
                      <a:gd name="connsiteX10" fmla="*/ 52388 w 1352550"/>
                      <a:gd name="connsiteY10" fmla="*/ 1042988 h 1062038"/>
                      <a:gd name="connsiteX11" fmla="*/ 19050 w 1352550"/>
                      <a:gd name="connsiteY11" fmla="*/ 952500 h 106203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</a:cxnLst>
                    <a:rect l="l" t="t" r="r" b="b"/>
                    <a:pathLst>
                      <a:path w="1352550" h="1062038" extrusionOk="0">
                        <a:moveTo>
                          <a:pt x="19050" y="952500"/>
                        </a:moveTo>
                        <a:lnTo>
                          <a:pt x="0" y="595313"/>
                        </a:lnTo>
                        <a:lnTo>
                          <a:pt x="295275" y="180975"/>
                        </a:lnTo>
                        <a:lnTo>
                          <a:pt x="666750" y="52388"/>
                        </a:lnTo>
                        <a:lnTo>
                          <a:pt x="1062038" y="0"/>
                        </a:lnTo>
                        <a:lnTo>
                          <a:pt x="1304925" y="180975"/>
                        </a:lnTo>
                        <a:lnTo>
                          <a:pt x="1352550" y="542925"/>
                        </a:lnTo>
                        <a:lnTo>
                          <a:pt x="1300163" y="823913"/>
                        </a:lnTo>
                        <a:lnTo>
                          <a:pt x="766763" y="1028700"/>
                        </a:lnTo>
                        <a:lnTo>
                          <a:pt x="266700" y="1062038"/>
                        </a:lnTo>
                        <a:lnTo>
                          <a:pt x="52388" y="1042988"/>
                        </a:lnTo>
                        <a:lnTo>
                          <a:pt x="19050" y="952500"/>
                        </a:lnTo>
                        <a:close/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>
                      <a:defRPr/>
                    </a:pPr>
                    <a:endParaRPr lang="de-DE"/>
                  </a:p>
                </p:txBody>
              </p:sp>
              <p:sp>
                <p:nvSpPr>
                  <p:cNvPr id="24" name="Rechteck 23"/>
                  <p:cNvSpPr/>
                  <p:nvPr/>
                </p:nvSpPr>
                <p:spPr bwMode="auto">
                  <a:xfrm>
                    <a:off x="3007520" y="5934075"/>
                    <a:ext cx="1757362" cy="495300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>
                      <a:defRPr/>
                    </a:pPr>
                    <a:endParaRPr lang="de-DE"/>
                  </a:p>
                </p:txBody>
              </p:sp>
              <p:cxnSp>
                <p:nvCxnSpPr>
                  <p:cNvPr id="27" name="Gerader Verbinder 26"/>
                  <p:cNvCxnSpPr>
                    <a:cxnSpLocks/>
                  </p:cNvCxnSpPr>
                  <p:nvPr/>
                </p:nvCxnSpPr>
                <p:spPr bwMode="auto">
                  <a:xfrm>
                    <a:off x="5405438" y="4983956"/>
                    <a:ext cx="0" cy="1921669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" name="Gerader Verbinder 27"/>
                  <p:cNvCxnSpPr>
                    <a:cxnSpLocks/>
                  </p:cNvCxnSpPr>
                  <p:nvPr/>
                </p:nvCxnSpPr>
                <p:spPr bwMode="auto">
                  <a:xfrm>
                    <a:off x="6281738" y="4983956"/>
                    <a:ext cx="0" cy="1921669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Gerader Verbinder 29"/>
                  <p:cNvCxnSpPr>
                    <a:cxnSpLocks/>
                  </p:cNvCxnSpPr>
                  <p:nvPr/>
                </p:nvCxnSpPr>
                <p:spPr bwMode="auto">
                  <a:xfrm>
                    <a:off x="5405438" y="5867399"/>
                    <a:ext cx="876299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2" name="Textfeld 31"/>
                <p:cNvSpPr txBox="1"/>
                <p:nvPr/>
              </p:nvSpPr>
              <p:spPr bwMode="auto">
                <a:xfrm>
                  <a:off x="793065" y="4619323"/>
                  <a:ext cx="6864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defRPr/>
                  </a:pPr>
                  <a:r>
                    <a:rPr lang="de-DE" sz="1200" b="1"/>
                    <a:t>All cells</a:t>
                  </a:r>
                </a:p>
              </p:txBody>
            </p:sp>
            <p:sp>
              <p:nvSpPr>
                <p:cNvPr id="33" name="Textfeld 32"/>
                <p:cNvSpPr txBox="1"/>
                <p:nvPr/>
              </p:nvSpPr>
              <p:spPr bwMode="auto">
                <a:xfrm>
                  <a:off x="3055327" y="4619323"/>
                  <a:ext cx="68640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defRPr/>
                  </a:pPr>
                  <a:r>
                    <a:rPr lang="de-DE" sz="1200" b="1"/>
                    <a:t>Singlets</a:t>
                  </a:r>
                </a:p>
              </p:txBody>
            </p:sp>
            <p:sp>
              <p:nvSpPr>
                <p:cNvPr id="34" name="Textfeld 33"/>
                <p:cNvSpPr txBox="1"/>
                <p:nvPr/>
              </p:nvSpPr>
              <p:spPr bwMode="auto">
                <a:xfrm>
                  <a:off x="5398785" y="4619322"/>
                  <a:ext cx="80199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defRPr/>
                  </a:pPr>
                  <a:r>
                    <a:rPr lang="de-DE" sz="1200" b="1"/>
                    <a:t>Live cells</a:t>
                  </a:r>
                </a:p>
              </p:txBody>
            </p:sp>
            <p:cxnSp>
              <p:nvCxnSpPr>
                <p:cNvPr id="36" name="Gerade Verbindung mit Pfeil 35"/>
                <p:cNvCxnSpPr>
                  <a:cxnSpLocks/>
                  <a:stCxn id="32" idx="3"/>
                  <a:endCxn id="33" idx="1"/>
                </p:cNvCxnSpPr>
                <p:nvPr/>
              </p:nvCxnSpPr>
              <p:spPr bwMode="auto">
                <a:xfrm>
                  <a:off x="1479471" y="4757823"/>
                  <a:ext cx="1575856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Gerade Verbindung mit Pfeil 37"/>
                <p:cNvCxnSpPr>
                  <a:cxnSpLocks/>
                  <a:stCxn id="33" idx="3"/>
                  <a:endCxn id="34" idx="1"/>
                </p:cNvCxnSpPr>
                <p:nvPr/>
              </p:nvCxnSpPr>
              <p:spPr bwMode="auto">
                <a:xfrm flipV="1">
                  <a:off x="3741733" y="4757822"/>
                  <a:ext cx="1657052" cy="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0" name="Textfeld 39"/>
              <p:cNvSpPr txBox="1"/>
              <p:nvPr/>
            </p:nvSpPr>
            <p:spPr bwMode="auto">
              <a:xfrm>
                <a:off x="-33144" y="3726767"/>
                <a:ext cx="9621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de-DE" sz="1200" b="1"/>
                  <a:t>CD4</a:t>
                </a:r>
                <a:r>
                  <a:rPr lang="de-DE" sz="1200" b="1" baseline="30000"/>
                  <a:t>+</a:t>
                </a:r>
                <a:r>
                  <a:rPr lang="de-DE" sz="1200" b="1"/>
                  <a:t> T cells:</a:t>
                </a:r>
                <a:endParaRPr/>
              </a:p>
            </p:txBody>
          </p:sp>
        </p:grpSp>
        <p:sp>
          <p:nvSpPr>
            <p:cNvPr id="22" name="TextBox 21"/>
            <p:cNvSpPr txBox="1"/>
            <p:nvPr/>
          </p:nvSpPr>
          <p:spPr bwMode="auto">
            <a:xfrm>
              <a:off x="-48990" y="4750461"/>
              <a:ext cx="5577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b="1"/>
                <a:t>B</a:t>
              </a:r>
              <a:endParaRPr/>
            </a:p>
          </p:txBody>
        </p:sp>
      </p:grpSp>
      <p:grpSp>
        <p:nvGrpSpPr>
          <p:cNvPr id="35" name="Group 34"/>
          <p:cNvGrpSpPr/>
          <p:nvPr/>
        </p:nvGrpSpPr>
        <p:grpSpPr bwMode="auto">
          <a:xfrm>
            <a:off x="-57957" y="7439720"/>
            <a:ext cx="6899627" cy="3374817"/>
            <a:chOff x="-57957" y="8128246"/>
            <a:chExt cx="6899627" cy="3374817"/>
          </a:xfrm>
        </p:grpSpPr>
        <p:grpSp>
          <p:nvGrpSpPr>
            <p:cNvPr id="70" name="Gruppieren 69"/>
            <p:cNvGrpSpPr/>
            <p:nvPr/>
          </p:nvGrpSpPr>
          <p:grpSpPr bwMode="auto">
            <a:xfrm>
              <a:off x="-57957" y="8416173"/>
              <a:ext cx="6899627" cy="3086890"/>
              <a:chOff x="-50562" y="2060781"/>
              <a:chExt cx="6899627" cy="3086890"/>
            </a:xfrm>
          </p:grpSpPr>
          <p:pic>
            <p:nvPicPr>
              <p:cNvPr id="43" name="Grafik 42"/>
              <p:cNvPicPr>
                <a:picLocks noChangeAspect="1"/>
              </p:cNvPicPr>
              <p:nvPr/>
            </p:nvPicPr>
            <p:blipFill>
              <a:blip r:embed="rId8">
                <a:grayscl/>
              </a:blip>
              <a:srcRect l="7320" b="7296"/>
              <a:stretch/>
            </p:blipFill>
            <p:spPr bwMode="auto">
              <a:xfrm>
                <a:off x="235837" y="3002132"/>
                <a:ext cx="1952998" cy="1910090"/>
              </a:xfrm>
              <a:prstGeom prst="rect">
                <a:avLst/>
              </a:prstGeom>
            </p:spPr>
          </p:pic>
          <p:pic>
            <p:nvPicPr>
              <p:cNvPr id="44" name="Grafik 43"/>
              <p:cNvPicPr>
                <a:picLocks noChangeAspect="1"/>
              </p:cNvPicPr>
              <p:nvPr/>
            </p:nvPicPr>
            <p:blipFill>
              <a:blip r:embed="rId9">
                <a:grayscl/>
              </a:blip>
              <a:srcRect l="7320" b="8265"/>
              <a:stretch/>
            </p:blipFill>
            <p:spPr bwMode="auto">
              <a:xfrm>
                <a:off x="2504091" y="3002522"/>
                <a:ext cx="1952998" cy="1890150"/>
              </a:xfrm>
              <a:prstGeom prst="rect">
                <a:avLst/>
              </a:prstGeom>
            </p:spPr>
          </p:pic>
          <p:pic>
            <p:nvPicPr>
              <p:cNvPr id="45" name="Grafik 44"/>
              <p:cNvPicPr>
                <a:picLocks noChangeAspect="1"/>
              </p:cNvPicPr>
              <p:nvPr/>
            </p:nvPicPr>
            <p:blipFill>
              <a:blip r:embed="rId10"/>
              <a:srcRect l="9203" b="6988"/>
              <a:stretch/>
            </p:blipFill>
            <p:spPr bwMode="auto">
              <a:xfrm>
                <a:off x="4800696" y="2973574"/>
                <a:ext cx="1913332" cy="1916464"/>
              </a:xfrm>
              <a:prstGeom prst="rect">
                <a:avLst/>
              </a:prstGeom>
            </p:spPr>
          </p:pic>
          <p:cxnSp>
            <p:nvCxnSpPr>
              <p:cNvPr id="46" name="Gerade Verbindung mit Pfeil 45"/>
              <p:cNvCxnSpPr>
                <a:cxnSpLocks/>
              </p:cNvCxnSpPr>
              <p:nvPr/>
            </p:nvCxnSpPr>
            <p:spPr bwMode="auto">
              <a:xfrm flipV="1">
                <a:off x="189224" y="2938966"/>
                <a:ext cx="0" cy="194828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feld 129"/>
              <p:cNvSpPr txBox="1"/>
              <p:nvPr/>
            </p:nvSpPr>
            <p:spPr bwMode="auto">
              <a:xfrm rot="16199998">
                <a:off x="-187384" y="3707793"/>
                <a:ext cx="513429" cy="2397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  <a:defRPr/>
                </a:pPr>
                <a:r>
                  <a:rPr lang="de-DE" sz="1200" b="1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SSC</a:t>
                </a:r>
                <a:endParaRPr lang="en-US" sz="1100"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48" name="Textfeld 133"/>
              <p:cNvSpPr txBox="1"/>
              <p:nvPr/>
            </p:nvSpPr>
            <p:spPr bwMode="auto">
              <a:xfrm>
                <a:off x="920044" y="4887252"/>
                <a:ext cx="533116" cy="24175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  <a:defRPr/>
                </a:pPr>
                <a:r>
                  <a:rPr lang="de-DE" sz="1100" b="1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FSC</a:t>
                </a:r>
                <a:endParaRPr lang="en-US" sz="1100">
                  <a:latin typeface="Calibri"/>
                  <a:ea typeface="Calibri"/>
                  <a:cs typeface="Times New Roman"/>
                </a:endParaRPr>
              </a:p>
            </p:txBody>
          </p:sp>
          <p:cxnSp>
            <p:nvCxnSpPr>
              <p:cNvPr id="49" name="Gerade Verbindung mit Pfeil 48"/>
              <p:cNvCxnSpPr>
                <a:cxnSpLocks/>
              </p:cNvCxnSpPr>
              <p:nvPr/>
            </p:nvCxnSpPr>
            <p:spPr bwMode="auto">
              <a:xfrm>
                <a:off x="189224" y="4887252"/>
                <a:ext cx="2060573" cy="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Gerade Verbindung mit Pfeil 49"/>
              <p:cNvCxnSpPr>
                <a:cxnSpLocks/>
              </p:cNvCxnSpPr>
              <p:nvPr/>
            </p:nvCxnSpPr>
            <p:spPr bwMode="auto">
              <a:xfrm flipV="1">
                <a:off x="2480650" y="2938966"/>
                <a:ext cx="0" cy="194828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feld 129"/>
              <p:cNvSpPr txBox="1"/>
              <p:nvPr/>
            </p:nvSpPr>
            <p:spPr bwMode="auto">
              <a:xfrm rot="16199998">
                <a:off x="2087251" y="3691003"/>
                <a:ext cx="547010" cy="2397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  <a:defRPr/>
                </a:pPr>
                <a:r>
                  <a:rPr lang="de-DE" sz="1200" b="1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FSC-H</a:t>
                </a:r>
                <a:endParaRPr lang="en-US" sz="1100"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52" name="Textfeld 133"/>
              <p:cNvSpPr txBox="1"/>
              <p:nvPr/>
            </p:nvSpPr>
            <p:spPr bwMode="auto">
              <a:xfrm>
                <a:off x="3211470" y="4887252"/>
                <a:ext cx="533116" cy="24175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  <a:defRPr/>
                </a:pPr>
                <a:r>
                  <a:rPr lang="de-DE" sz="1100" b="1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FSC-A</a:t>
                </a:r>
                <a:endParaRPr lang="en-US" sz="1100">
                  <a:latin typeface="Calibri"/>
                  <a:ea typeface="Calibri"/>
                  <a:cs typeface="Times New Roman"/>
                </a:endParaRPr>
              </a:p>
            </p:txBody>
          </p:sp>
          <p:cxnSp>
            <p:nvCxnSpPr>
              <p:cNvPr id="53" name="Gerade Verbindung mit Pfeil 52"/>
              <p:cNvCxnSpPr>
                <a:cxnSpLocks/>
              </p:cNvCxnSpPr>
              <p:nvPr/>
            </p:nvCxnSpPr>
            <p:spPr bwMode="auto">
              <a:xfrm>
                <a:off x="2480650" y="4887252"/>
                <a:ext cx="2060574" cy="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Gerade Verbindung mit Pfeil 53"/>
              <p:cNvCxnSpPr>
                <a:cxnSpLocks/>
              </p:cNvCxnSpPr>
              <p:nvPr/>
            </p:nvCxnSpPr>
            <p:spPr bwMode="auto">
              <a:xfrm flipV="1">
                <a:off x="4788491" y="2938966"/>
                <a:ext cx="0" cy="194828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Textfeld 129"/>
              <p:cNvSpPr txBox="1"/>
              <p:nvPr/>
            </p:nvSpPr>
            <p:spPr bwMode="auto">
              <a:xfrm rot="16199998">
                <a:off x="4366519" y="3662429"/>
                <a:ext cx="604158" cy="2397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  <a:defRPr/>
                </a:pPr>
                <a:r>
                  <a:rPr lang="de-DE" sz="1200" b="1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Count</a:t>
                </a:r>
                <a:endParaRPr lang="en-US" sz="1100"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56" name="Textfeld 133"/>
              <p:cNvSpPr txBox="1"/>
              <p:nvPr/>
            </p:nvSpPr>
            <p:spPr bwMode="auto">
              <a:xfrm>
                <a:off x="5324111" y="4866596"/>
                <a:ext cx="975423" cy="28107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  <a:defRPr/>
                </a:pPr>
                <a:r>
                  <a:rPr lang="de-DE" sz="1100" b="1" dirty="0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Viability Dye</a:t>
                </a:r>
                <a:endParaRPr lang="en-US" sz="1100" dirty="0">
                  <a:latin typeface="Calibri"/>
                  <a:ea typeface="Calibri"/>
                  <a:cs typeface="Times New Roman"/>
                </a:endParaRPr>
              </a:p>
            </p:txBody>
          </p:sp>
          <p:cxnSp>
            <p:nvCxnSpPr>
              <p:cNvPr id="57" name="Gerade Verbindung mit Pfeil 56"/>
              <p:cNvCxnSpPr>
                <a:cxnSpLocks/>
              </p:cNvCxnSpPr>
              <p:nvPr/>
            </p:nvCxnSpPr>
            <p:spPr bwMode="auto">
              <a:xfrm>
                <a:off x="4788491" y="4887252"/>
                <a:ext cx="2060574" cy="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8" name="Rechteck 57"/>
              <p:cNvSpPr/>
              <p:nvPr/>
            </p:nvSpPr>
            <p:spPr bwMode="auto">
              <a:xfrm>
                <a:off x="2802582" y="3854814"/>
                <a:ext cx="1587372" cy="44739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>
                  <a:defRPr/>
                </a:pPr>
                <a:endParaRPr lang="de-DE"/>
              </a:p>
            </p:txBody>
          </p:sp>
          <p:cxnSp>
            <p:nvCxnSpPr>
              <p:cNvPr id="59" name="Gerader Verbinder 58"/>
              <p:cNvCxnSpPr>
                <a:cxnSpLocks/>
              </p:cNvCxnSpPr>
              <p:nvPr/>
            </p:nvCxnSpPr>
            <p:spPr bwMode="auto">
              <a:xfrm>
                <a:off x="5743249" y="2996600"/>
                <a:ext cx="0" cy="173578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Gerader Verbinder 59"/>
              <p:cNvCxnSpPr>
                <a:cxnSpLocks/>
              </p:cNvCxnSpPr>
              <p:nvPr/>
            </p:nvCxnSpPr>
            <p:spPr bwMode="auto">
              <a:xfrm>
                <a:off x="6534785" y="2996600"/>
                <a:ext cx="0" cy="173578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Gerader Verbinder 60"/>
              <p:cNvCxnSpPr>
                <a:cxnSpLocks/>
              </p:cNvCxnSpPr>
              <p:nvPr/>
            </p:nvCxnSpPr>
            <p:spPr bwMode="auto">
              <a:xfrm>
                <a:off x="5743249" y="3794588"/>
                <a:ext cx="79153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feld 61"/>
              <p:cNvSpPr txBox="1"/>
              <p:nvPr/>
            </p:nvSpPr>
            <p:spPr bwMode="auto">
              <a:xfrm>
                <a:off x="869855" y="2398849"/>
                <a:ext cx="6864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de-DE" sz="1200" b="1"/>
                  <a:t>All cells</a:t>
                </a:r>
              </a:p>
            </p:txBody>
          </p:sp>
          <p:sp>
            <p:nvSpPr>
              <p:cNvPr id="63" name="Textfeld 62"/>
              <p:cNvSpPr txBox="1"/>
              <p:nvPr/>
            </p:nvSpPr>
            <p:spPr bwMode="auto">
              <a:xfrm>
                <a:off x="3132117" y="2398849"/>
                <a:ext cx="6864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de-DE" sz="1200" b="1"/>
                  <a:t>Singlets</a:t>
                </a:r>
              </a:p>
            </p:txBody>
          </p:sp>
          <p:sp>
            <p:nvSpPr>
              <p:cNvPr id="64" name="Textfeld 63"/>
              <p:cNvSpPr txBox="1"/>
              <p:nvPr/>
            </p:nvSpPr>
            <p:spPr bwMode="auto">
              <a:xfrm>
                <a:off x="5475575" y="2398848"/>
                <a:ext cx="8019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de-DE" sz="1200" b="1"/>
                  <a:t>Live cells</a:t>
                </a:r>
              </a:p>
            </p:txBody>
          </p:sp>
          <p:cxnSp>
            <p:nvCxnSpPr>
              <p:cNvPr id="65" name="Gerade Verbindung mit Pfeil 64"/>
              <p:cNvCxnSpPr>
                <a:cxnSpLocks/>
                <a:stCxn id="62" idx="3"/>
                <a:endCxn id="63" idx="1"/>
              </p:cNvCxnSpPr>
              <p:nvPr/>
            </p:nvCxnSpPr>
            <p:spPr bwMode="auto">
              <a:xfrm>
                <a:off x="1556261" y="2537349"/>
                <a:ext cx="1575856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Gerade Verbindung mit Pfeil 65"/>
              <p:cNvCxnSpPr>
                <a:cxnSpLocks/>
                <a:stCxn id="63" idx="3"/>
                <a:endCxn id="64" idx="1"/>
              </p:cNvCxnSpPr>
              <p:nvPr/>
            </p:nvCxnSpPr>
            <p:spPr bwMode="auto">
              <a:xfrm flipV="1">
                <a:off x="3818523" y="2537348"/>
                <a:ext cx="1657052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Freihandform: Form 67"/>
              <p:cNvSpPr/>
              <p:nvPr/>
            </p:nvSpPr>
            <p:spPr bwMode="auto">
              <a:xfrm>
                <a:off x="565150" y="3613150"/>
                <a:ext cx="1390650" cy="1092200"/>
              </a:xfrm>
              <a:custGeom>
                <a:avLst/>
                <a:gdLst>
                  <a:gd name="connsiteX0" fmla="*/ 165100 w 1390650"/>
                  <a:gd name="connsiteY0" fmla="*/ 1092200 h 1092200"/>
                  <a:gd name="connsiteX1" fmla="*/ 762000 w 1390650"/>
                  <a:gd name="connsiteY1" fmla="*/ 946150 h 1092200"/>
                  <a:gd name="connsiteX2" fmla="*/ 1390650 w 1390650"/>
                  <a:gd name="connsiteY2" fmla="*/ 558800 h 1092200"/>
                  <a:gd name="connsiteX3" fmla="*/ 1130300 w 1390650"/>
                  <a:gd name="connsiteY3" fmla="*/ 101600 h 1092200"/>
                  <a:gd name="connsiteX4" fmla="*/ 546100 w 1390650"/>
                  <a:gd name="connsiteY4" fmla="*/ 0 h 1092200"/>
                  <a:gd name="connsiteX5" fmla="*/ 158750 w 1390650"/>
                  <a:gd name="connsiteY5" fmla="*/ 44450 h 1092200"/>
                  <a:gd name="connsiteX6" fmla="*/ 6350 w 1390650"/>
                  <a:gd name="connsiteY6" fmla="*/ 463550 h 1092200"/>
                  <a:gd name="connsiteX7" fmla="*/ 0 w 1390650"/>
                  <a:gd name="connsiteY7" fmla="*/ 965200 h 1092200"/>
                  <a:gd name="connsiteX8" fmla="*/ 114300 w 1390650"/>
                  <a:gd name="connsiteY8" fmla="*/ 1073150 h 1092200"/>
                  <a:gd name="connsiteX9" fmla="*/ 165100 w 1390650"/>
                  <a:gd name="connsiteY9" fmla="*/ 1092200 h 1092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1390650" h="1092200" extrusionOk="0">
                    <a:moveTo>
                      <a:pt x="165100" y="1092200"/>
                    </a:moveTo>
                    <a:lnTo>
                      <a:pt x="762000" y="946150"/>
                    </a:lnTo>
                    <a:lnTo>
                      <a:pt x="1390650" y="558800"/>
                    </a:lnTo>
                    <a:lnTo>
                      <a:pt x="1130300" y="101600"/>
                    </a:lnTo>
                    <a:lnTo>
                      <a:pt x="546100" y="0"/>
                    </a:lnTo>
                    <a:lnTo>
                      <a:pt x="158750" y="44450"/>
                    </a:lnTo>
                    <a:lnTo>
                      <a:pt x="6350" y="463550"/>
                    </a:lnTo>
                    <a:cubicBezTo>
                      <a:pt x="4233" y="630767"/>
                      <a:pt x="2117" y="797983"/>
                      <a:pt x="0" y="965200"/>
                    </a:cubicBezTo>
                    <a:lnTo>
                      <a:pt x="114300" y="1073150"/>
                    </a:lnTo>
                    <a:lnTo>
                      <a:pt x="165100" y="1092200"/>
                    </a:lnTo>
                    <a:close/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69" name="Textfeld 68"/>
              <p:cNvSpPr txBox="1"/>
              <p:nvPr/>
            </p:nvSpPr>
            <p:spPr bwMode="auto">
              <a:xfrm>
                <a:off x="0" y="2060781"/>
                <a:ext cx="10884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de-DE" sz="1200" b="1"/>
                  <a:t>Macrophages:</a:t>
                </a:r>
                <a:endParaRPr/>
              </a:p>
            </p:txBody>
          </p:sp>
        </p:grpSp>
        <p:sp>
          <p:nvSpPr>
            <p:cNvPr id="25" name="TextBox 24"/>
            <p:cNvSpPr txBox="1"/>
            <p:nvPr/>
          </p:nvSpPr>
          <p:spPr bwMode="auto">
            <a:xfrm>
              <a:off x="-48990" y="8128246"/>
              <a:ext cx="5577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b="1"/>
                <a:t>C</a:t>
              </a:r>
              <a:endParaRPr/>
            </a:p>
          </p:txBody>
        </p:sp>
      </p:grpSp>
      <p:sp>
        <p:nvSpPr>
          <p:cNvPr id="37" name="Titel 1"/>
          <p:cNvSpPr txBox="1"/>
          <p:nvPr/>
        </p:nvSpPr>
        <p:spPr bwMode="auto">
          <a:xfrm>
            <a:off x="-24377" y="10952934"/>
            <a:ext cx="6841669" cy="65794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 lnSpcReduction="10000"/>
          </a:bodyPr>
          <a:lstStyle>
            <a:lvl1pPr algn="l" defTabSz="685800">
              <a:lnSpc>
                <a:spcPct val="90000"/>
              </a:lnSpc>
              <a:spcBef>
                <a:spcPts val="0"/>
              </a:spcBef>
              <a:buNone/>
              <a:defRPr sz="33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defRPr/>
            </a:pPr>
            <a:r>
              <a:rPr lang="de-DE" sz="1400" b="1" dirty="0"/>
              <a:t>Figure S1: </a:t>
            </a:r>
            <a:r>
              <a:rPr lang="en-US" sz="1400" b="0" i="0" u="none" strike="noStrike" dirty="0">
                <a:latin typeface="Calibri"/>
              </a:rPr>
              <a:t>Representative flow cytometric gating strategies used for </a:t>
            </a:r>
            <a:r>
              <a:rPr lang="en-US" sz="1400" b="0" i="0" u="none" strike="noStrike" dirty="0" err="1">
                <a:latin typeface="Calibri"/>
              </a:rPr>
              <a:t>iPRF</a:t>
            </a:r>
            <a:r>
              <a:rPr lang="en-US" sz="1400" b="0" i="0" u="none" strike="noStrike" dirty="0">
                <a:latin typeface="Calibri"/>
              </a:rPr>
              <a:t> derived platelets (</a:t>
            </a:r>
            <a:r>
              <a:rPr lang="en-US" sz="1400" b="1" i="0" u="none" strike="noStrike" dirty="0">
                <a:latin typeface="Calibri,Bold"/>
              </a:rPr>
              <a:t>A</a:t>
            </a:r>
            <a:r>
              <a:rPr lang="en-US" sz="1400" b="0" i="0" u="none" strike="noStrike" dirty="0">
                <a:latin typeface="Calibri"/>
              </a:rPr>
              <a:t>), CD4</a:t>
            </a:r>
            <a:r>
              <a:rPr lang="en-US" sz="1400" b="0" i="0" u="none" strike="noStrike" baseline="30000" dirty="0">
                <a:latin typeface="Calibri"/>
              </a:rPr>
              <a:t>+</a:t>
            </a:r>
            <a:r>
              <a:rPr lang="en-US" sz="1400" b="0" i="0" u="none" strike="noStrike" dirty="0">
                <a:latin typeface="Calibri"/>
              </a:rPr>
              <a:t> T cells (</a:t>
            </a:r>
            <a:r>
              <a:rPr lang="en-US" sz="1400" b="1" i="0" u="none" strike="noStrike" dirty="0">
                <a:latin typeface="Calibri,Bold"/>
              </a:rPr>
              <a:t>B</a:t>
            </a:r>
            <a:r>
              <a:rPr lang="en-US" sz="1400" b="0" i="0" u="none" strike="noStrike" dirty="0">
                <a:latin typeface="Calibri"/>
              </a:rPr>
              <a:t>), and monocyte derived macrophages (</a:t>
            </a:r>
            <a:r>
              <a:rPr lang="en-US" sz="1400" b="1" i="0" u="none" strike="noStrike" dirty="0">
                <a:latin typeface="Calibri,Bold"/>
              </a:rPr>
              <a:t>C</a:t>
            </a:r>
            <a:r>
              <a:rPr lang="en-US" sz="1400" b="0" i="0" u="none" strike="noStrike" dirty="0">
                <a:latin typeface="Calibri"/>
              </a:rPr>
              <a:t>). Debris, doublets, and dead cells were excluded from analysis.</a:t>
            </a:r>
            <a:r>
              <a:rPr lang="de-DE" sz="1400" dirty="0"/>
              <a:t> </a:t>
            </a:r>
            <a:endParaRPr lang="en-US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Arial"/>
        <a:cs typeface="Arial"/>
      </a:majorFont>
      <a:minorFont>
        <a:latin typeface="Calibri"/>
        <a:ea typeface="Arial"/>
        <a:cs typeface="Arial"/>
      </a:minorFont>
    </a:fontScheme>
    <a:fmtScheme name="Office Theme">
      <a:fillStyleLst>
        <a:solidFill>
          <a:schemeClr val="phClr"/>
        </a:solidFill>
        <a:gradFill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3</Words>
  <Application>Microsoft Office PowerPoint</Application>
  <DocSecurity>0</DocSecurity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,Bold</vt:lpstr>
      <vt:lpstr>Arial</vt:lpstr>
      <vt:lpstr>Calibri</vt:lpstr>
      <vt:lpstr>Calibri Light</vt:lpstr>
      <vt:lpstr>Office Theme</vt:lpstr>
      <vt:lpstr>Flow cytometric gating strategies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: Flow cytometric gating strategies</dc:title>
  <dc:subject/>
  <dc:creator>Trzeciak, Emily Renee</dc:creator>
  <cp:keywords/>
  <dc:description/>
  <cp:lastModifiedBy>MDPI</cp:lastModifiedBy>
  <cp:revision>5</cp:revision>
  <dcterms:created xsi:type="dcterms:W3CDTF">2022-10-22T08:01:06Z</dcterms:created>
  <dcterms:modified xsi:type="dcterms:W3CDTF">2022-12-06T06:35:40Z</dcterms:modified>
  <cp:category/>
  <dc:identifier/>
  <cp:contentStatus/>
  <dc:language/>
  <cp:version/>
</cp:coreProperties>
</file>